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10880" y="8921601"/>
            <a:ext cx="6839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SNP-index plots for 20 pseudomolecules of rust susceptible bulk with resistant pare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lines indicate the sliding window average of 2Mb interval with 50 kb increment for SNP-index.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0" y="-5403"/>
            <a:ext cx="6835140" cy="8720343"/>
            <a:chOff x="0" y="-30481"/>
            <a:chExt cx="6835140" cy="8720343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00" t="16813" r="52111"/>
            <a:stretch/>
          </p:blipFill>
          <p:spPr>
            <a:xfrm>
              <a:off x="2290075" y="0"/>
              <a:ext cx="2274835" cy="6201932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333"/>
            <a:stretch/>
          </p:blipFill>
          <p:spPr>
            <a:xfrm>
              <a:off x="0" y="0"/>
              <a:ext cx="2252772" cy="745542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10" r="2345" b="66445"/>
            <a:stretch/>
          </p:blipFill>
          <p:spPr>
            <a:xfrm>
              <a:off x="4587770" y="4961376"/>
              <a:ext cx="2240613" cy="2501666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00" r="52111" b="83187"/>
            <a:stretch/>
          </p:blipFill>
          <p:spPr>
            <a:xfrm>
              <a:off x="0" y="7436372"/>
              <a:ext cx="2274835" cy="125349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11" r="27341" b="66670"/>
            <a:stretch/>
          </p:blipFill>
          <p:spPr>
            <a:xfrm>
              <a:off x="2257056" y="6201932"/>
              <a:ext cx="2240945" cy="2484868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11" t="33299" r="27341"/>
            <a:stretch/>
          </p:blipFill>
          <p:spPr>
            <a:xfrm>
              <a:off x="4594195" y="-30481"/>
              <a:ext cx="2240945" cy="4972833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0</TotalTime>
  <Words>33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89</cp:revision>
  <dcterms:created xsi:type="dcterms:W3CDTF">2015-04-20T11:32:42Z</dcterms:created>
  <dcterms:modified xsi:type="dcterms:W3CDTF">2016-09-26T10:47:02Z</dcterms:modified>
</cp:coreProperties>
</file>